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70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50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1EAF5-8744-4339-8490-657AB06C7F18}" type="datetimeFigureOut">
              <a:rPr kumimoji="1" lang="ja-JP" altLang="en-US" smtClean="0"/>
              <a:t>2020/8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BA61D-8B7E-46B4-9AD9-E5F0D06881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97875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1EAF5-8744-4339-8490-657AB06C7F18}" type="datetimeFigureOut">
              <a:rPr kumimoji="1" lang="ja-JP" altLang="en-US" smtClean="0"/>
              <a:t>2020/8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BA61D-8B7E-46B4-9AD9-E5F0D06881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2171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1EAF5-8744-4339-8490-657AB06C7F18}" type="datetimeFigureOut">
              <a:rPr kumimoji="1" lang="ja-JP" altLang="en-US" smtClean="0"/>
              <a:t>2020/8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BA61D-8B7E-46B4-9AD9-E5F0D06881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73527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1EAF5-8744-4339-8490-657AB06C7F18}" type="datetimeFigureOut">
              <a:rPr kumimoji="1" lang="ja-JP" altLang="en-US" smtClean="0"/>
              <a:t>2020/8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BA61D-8B7E-46B4-9AD9-E5F0D06881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40450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1EAF5-8744-4339-8490-657AB06C7F18}" type="datetimeFigureOut">
              <a:rPr kumimoji="1" lang="ja-JP" altLang="en-US" smtClean="0"/>
              <a:t>2020/8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BA61D-8B7E-46B4-9AD9-E5F0D06881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64786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1EAF5-8744-4339-8490-657AB06C7F18}" type="datetimeFigureOut">
              <a:rPr kumimoji="1" lang="ja-JP" altLang="en-US" smtClean="0"/>
              <a:t>2020/8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BA61D-8B7E-46B4-9AD9-E5F0D06881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74706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1EAF5-8744-4339-8490-657AB06C7F18}" type="datetimeFigureOut">
              <a:rPr kumimoji="1" lang="ja-JP" altLang="en-US" smtClean="0"/>
              <a:t>2020/8/3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BA61D-8B7E-46B4-9AD9-E5F0D06881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63848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1EAF5-8744-4339-8490-657AB06C7F18}" type="datetimeFigureOut">
              <a:rPr kumimoji="1" lang="ja-JP" altLang="en-US" smtClean="0"/>
              <a:t>2020/8/3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BA61D-8B7E-46B4-9AD9-E5F0D06881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06039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1EAF5-8744-4339-8490-657AB06C7F18}" type="datetimeFigureOut">
              <a:rPr kumimoji="1" lang="ja-JP" altLang="en-US" smtClean="0"/>
              <a:t>2020/8/3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BA61D-8B7E-46B4-9AD9-E5F0D06881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56652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1EAF5-8744-4339-8490-657AB06C7F18}" type="datetimeFigureOut">
              <a:rPr kumimoji="1" lang="ja-JP" altLang="en-US" smtClean="0"/>
              <a:t>2020/8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BA61D-8B7E-46B4-9AD9-E5F0D06881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71559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D1EAF5-8744-4339-8490-657AB06C7F18}" type="datetimeFigureOut">
              <a:rPr kumimoji="1" lang="ja-JP" altLang="en-US" smtClean="0"/>
              <a:t>2020/8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0BA61D-8B7E-46B4-9AD9-E5F0D06881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18260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D1EAF5-8744-4339-8490-657AB06C7F18}" type="datetimeFigureOut">
              <a:rPr kumimoji="1" lang="ja-JP" altLang="en-US" smtClean="0"/>
              <a:t>2020/8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0BA61D-8B7E-46B4-9AD9-E5F0D06881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81938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36928BD6-76FF-4F32-94F9-E02CE1EFFC5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22602" y="379601"/>
            <a:ext cx="6400800" cy="6400800"/>
          </a:xfrm>
          <a:prstGeom prst="rect">
            <a:avLst/>
          </a:prstGeom>
        </p:spPr>
      </p:pic>
      <p:graphicFrame>
        <p:nvGraphicFramePr>
          <p:cNvPr id="6" name="表 5">
            <a:extLst>
              <a:ext uri="{FF2B5EF4-FFF2-40B4-BE49-F238E27FC236}">
                <a16:creationId xmlns:a16="http://schemas.microsoft.com/office/drawing/2014/main" id="{8869AAFC-65AC-4A9F-9044-9D0F95302FA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0834955"/>
              </p:ext>
            </p:extLst>
          </p:nvPr>
        </p:nvGraphicFramePr>
        <p:xfrm>
          <a:off x="7370336" y="2272295"/>
          <a:ext cx="1625600" cy="1712288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941137">
                  <a:extLst>
                    <a:ext uri="{9D8B030D-6E8A-4147-A177-3AD203B41FA5}">
                      <a16:colId xmlns:a16="http://schemas.microsoft.com/office/drawing/2014/main" val="641301747"/>
                    </a:ext>
                  </a:extLst>
                </a:gridCol>
                <a:gridCol w="684463">
                  <a:extLst>
                    <a:ext uri="{9D8B030D-6E8A-4147-A177-3AD203B41FA5}">
                      <a16:colId xmlns:a16="http://schemas.microsoft.com/office/drawing/2014/main" val="684344948"/>
                    </a:ext>
                  </a:extLst>
                </a:gridCol>
              </a:tblGrid>
              <a:tr h="247650"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597809971"/>
                  </a:ext>
                </a:extLst>
              </a:tr>
              <a:tr h="22638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oup 1 vs 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83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422905824"/>
                  </a:ext>
                </a:extLst>
              </a:tr>
              <a:tr h="2476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oup 1 vs 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7*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430227395"/>
                  </a:ext>
                </a:extLst>
              </a:tr>
              <a:tr h="2476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oup 1 vs 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*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43692164"/>
                  </a:ext>
                </a:extLst>
              </a:tr>
              <a:tr h="2476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oup 2 vs 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15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136282132"/>
                  </a:ext>
                </a:extLst>
              </a:tr>
              <a:tr h="2476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oup 2 vs 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2*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631896083"/>
                  </a:ext>
                </a:extLst>
              </a:tr>
              <a:tr h="2476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oup 3 vs 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3*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860142155"/>
                  </a:ext>
                </a:extLst>
              </a:tr>
            </a:tbl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DB72ADAD-68C2-47F3-A053-199EC7ECACEB}"/>
              </a:ext>
            </a:extLst>
          </p:cNvPr>
          <p:cNvSpPr txBox="1"/>
          <p:nvPr/>
        </p:nvSpPr>
        <p:spPr>
          <a:xfrm>
            <a:off x="7184097" y="1375795"/>
            <a:ext cx="739305" cy="83099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roup 1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roup 2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roup 3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roup 4</a:t>
            </a: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85240C06-2700-4DB7-94BB-7CE5CF107167}"/>
              </a:ext>
            </a:extLst>
          </p:cNvPr>
          <p:cNvSpPr/>
          <p:nvPr/>
        </p:nvSpPr>
        <p:spPr>
          <a:xfrm>
            <a:off x="5016617" y="917337"/>
            <a:ext cx="2701255" cy="41945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F4F394A1-4D95-4B17-B3F6-C7F7F42C845F}"/>
              </a:ext>
            </a:extLst>
          </p:cNvPr>
          <p:cNvSpPr txBox="1"/>
          <p:nvPr/>
        </p:nvSpPr>
        <p:spPr>
          <a:xfrm>
            <a:off x="2647049" y="281384"/>
            <a:ext cx="4151906" cy="83099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edian OS of Group 1; 98.7 months (95%CI: 72.7-NA)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edian OS of Group 2; 75.6 months (95%CI: 58.2-110.6)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edian OS of Group 3; 69.5 months (95%CI: 47.5-102.0)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edian OS of Group 4; 43.0 months (95%CI: 29.5-52.4)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7A8E463-BA9F-4C67-A997-41BDCAF793DD}"/>
              </a:ext>
            </a:extLst>
          </p:cNvPr>
          <p:cNvSpPr txBox="1"/>
          <p:nvPr/>
        </p:nvSpPr>
        <p:spPr>
          <a:xfrm>
            <a:off x="267707" y="442100"/>
            <a:ext cx="9549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Figure S1A</a:t>
            </a:r>
            <a:endParaRPr kumimoji="1" lang="ja-JP" altLang="en-US" sz="1400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CFBAB581-E2B5-4A29-9C8D-3A7C3AA2CA44}"/>
              </a:ext>
            </a:extLst>
          </p:cNvPr>
          <p:cNvSpPr txBox="1"/>
          <p:nvPr/>
        </p:nvSpPr>
        <p:spPr>
          <a:xfrm>
            <a:off x="1656826" y="5896234"/>
            <a:ext cx="739305" cy="83099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roup 1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roup 2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roup 3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roup 4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2745AF29-C46F-4599-B701-CE60802349E3}"/>
              </a:ext>
            </a:extLst>
          </p:cNvPr>
          <p:cNvSpPr txBox="1"/>
          <p:nvPr/>
        </p:nvSpPr>
        <p:spPr>
          <a:xfrm rot="16200000">
            <a:off x="860591" y="2989228"/>
            <a:ext cx="2335896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Overall survival             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20809078-9480-4BDF-A00E-1F5E85484575}"/>
              </a:ext>
            </a:extLst>
          </p:cNvPr>
          <p:cNvSpPr txBox="1"/>
          <p:nvPr/>
        </p:nvSpPr>
        <p:spPr>
          <a:xfrm>
            <a:off x="4546833" y="5440375"/>
            <a:ext cx="857927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872302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BA7D5337-A633-4DE2-A15A-D41D8049718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96099" y="435272"/>
            <a:ext cx="6400800" cy="6400800"/>
          </a:xfrm>
          <a:prstGeom prst="rect">
            <a:avLst/>
          </a:prstGeom>
        </p:spPr>
      </p:pic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8DD4A194-42A6-4D8E-8C2E-CF1278077F6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79763655"/>
              </p:ext>
            </p:extLst>
          </p:nvPr>
        </p:nvGraphicFramePr>
        <p:xfrm>
          <a:off x="7291897" y="2372212"/>
          <a:ext cx="1625600" cy="1712288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941137">
                  <a:extLst>
                    <a:ext uri="{9D8B030D-6E8A-4147-A177-3AD203B41FA5}">
                      <a16:colId xmlns:a16="http://schemas.microsoft.com/office/drawing/2014/main" val="641301747"/>
                    </a:ext>
                  </a:extLst>
                </a:gridCol>
                <a:gridCol w="684463">
                  <a:extLst>
                    <a:ext uri="{9D8B030D-6E8A-4147-A177-3AD203B41FA5}">
                      <a16:colId xmlns:a16="http://schemas.microsoft.com/office/drawing/2014/main" val="684344948"/>
                    </a:ext>
                  </a:extLst>
                </a:gridCol>
              </a:tblGrid>
              <a:tr h="247650"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597809971"/>
                  </a:ext>
                </a:extLst>
              </a:tr>
              <a:tr h="22638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oup 1 vs 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7*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422905824"/>
                  </a:ext>
                </a:extLst>
              </a:tr>
              <a:tr h="2476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oup 1 vs 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1*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430227395"/>
                  </a:ext>
                </a:extLst>
              </a:tr>
              <a:tr h="2476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oup 1 vs 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*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43692164"/>
                  </a:ext>
                </a:extLst>
              </a:tr>
              <a:tr h="2476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oup 2 vs 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2*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136282132"/>
                  </a:ext>
                </a:extLst>
              </a:tr>
              <a:tr h="2476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oup 2 vs 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*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631896083"/>
                  </a:ext>
                </a:extLst>
              </a:tr>
              <a:tr h="2476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oup 3 vs 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06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860142155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8692587-34D6-4A82-8BD0-E9E34695AF30}"/>
              </a:ext>
            </a:extLst>
          </p:cNvPr>
          <p:cNvSpPr txBox="1"/>
          <p:nvPr/>
        </p:nvSpPr>
        <p:spPr>
          <a:xfrm>
            <a:off x="7025242" y="1402290"/>
            <a:ext cx="739305" cy="83099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roup 1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roup 2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roup 3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roup 4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A2E7E787-437F-40BB-9518-DE4CC6D08403}"/>
              </a:ext>
            </a:extLst>
          </p:cNvPr>
          <p:cNvSpPr txBox="1"/>
          <p:nvPr/>
        </p:nvSpPr>
        <p:spPr>
          <a:xfrm>
            <a:off x="1455490" y="5938179"/>
            <a:ext cx="739305" cy="83099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roup 1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roup 2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roup 3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roup 4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2342293-00BD-4CA5-91AC-30A8785F4C7E}"/>
              </a:ext>
            </a:extLst>
          </p:cNvPr>
          <p:cNvSpPr txBox="1"/>
          <p:nvPr/>
        </p:nvSpPr>
        <p:spPr>
          <a:xfrm>
            <a:off x="233298" y="281383"/>
            <a:ext cx="9485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/>
              <a:t>Figure </a:t>
            </a:r>
            <a:r>
              <a:rPr kumimoji="1" lang="en-US" altLang="ja-JP" sz="1400" dirty="0"/>
              <a:t>S1B</a:t>
            </a:r>
            <a:endParaRPr kumimoji="1" lang="ja-JP" altLang="en-US" sz="1400" dirty="0"/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3D7F011D-7D3C-48CD-AC22-761F91AFD842}"/>
              </a:ext>
            </a:extLst>
          </p:cNvPr>
          <p:cNvSpPr/>
          <p:nvPr/>
        </p:nvSpPr>
        <p:spPr>
          <a:xfrm>
            <a:off x="4915949" y="982840"/>
            <a:ext cx="2701255" cy="41945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4789ADC-D269-42C8-9C9E-0F728D0FB7A8}"/>
              </a:ext>
            </a:extLst>
          </p:cNvPr>
          <p:cNvSpPr txBox="1"/>
          <p:nvPr/>
        </p:nvSpPr>
        <p:spPr>
          <a:xfrm>
            <a:off x="2508631" y="296065"/>
            <a:ext cx="4151906" cy="83099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edian OS of Group 1; NA months (95%CI: NA-NA)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edian OS of Group 2; 95.1 months (95%CI: 95.1-NA)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edian OS of Group 3; 70.5 months (95%CI: 47.1-NA)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edian OS of Group 4; 50.1 months (95%CI: 35.8-66.5)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E1D3E96B-4A28-4BC8-90CD-51127E41A3AE}"/>
              </a:ext>
            </a:extLst>
          </p:cNvPr>
          <p:cNvSpPr txBox="1"/>
          <p:nvPr/>
        </p:nvSpPr>
        <p:spPr>
          <a:xfrm rot="16200000">
            <a:off x="617310" y="2989228"/>
            <a:ext cx="2335896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Overall survival             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E652299B-7862-4E11-BC49-75E27711FF98}"/>
              </a:ext>
            </a:extLst>
          </p:cNvPr>
          <p:cNvSpPr txBox="1"/>
          <p:nvPr/>
        </p:nvSpPr>
        <p:spPr>
          <a:xfrm>
            <a:off x="4546833" y="5440375"/>
            <a:ext cx="857927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683672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6</TotalTime>
  <Words>236</Words>
  <Application>Microsoft Office PowerPoint</Application>
  <PresentationFormat>画面に合わせる (4:3)</PresentationFormat>
  <Paragraphs>56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 Y</dc:creator>
  <cp:lastModifiedBy>M Y</cp:lastModifiedBy>
  <cp:revision>9</cp:revision>
  <dcterms:created xsi:type="dcterms:W3CDTF">2020-08-21T11:48:20Z</dcterms:created>
  <dcterms:modified xsi:type="dcterms:W3CDTF">2020-08-31T05:59:25Z</dcterms:modified>
</cp:coreProperties>
</file>